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22" d="100"/>
          <a:sy n="122" d="100"/>
        </p:scale>
        <p:origin x="96" y="3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F408F-A0FD-4E90-9059-09F2FBAC3855}" type="datetimeFigureOut">
              <a:rPr lang="en-US" smtClean="0"/>
              <a:t>3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55148-D7E4-4E07-AC51-DA9CFB352B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25925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F408F-A0FD-4E90-9059-09F2FBAC3855}" type="datetimeFigureOut">
              <a:rPr lang="en-US" smtClean="0"/>
              <a:t>3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55148-D7E4-4E07-AC51-DA9CFB352B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5528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F408F-A0FD-4E90-9059-09F2FBAC3855}" type="datetimeFigureOut">
              <a:rPr lang="en-US" smtClean="0"/>
              <a:t>3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55148-D7E4-4E07-AC51-DA9CFB352B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51634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F408F-A0FD-4E90-9059-09F2FBAC3855}" type="datetimeFigureOut">
              <a:rPr lang="en-US" smtClean="0"/>
              <a:t>3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55148-D7E4-4E07-AC51-DA9CFB352B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97642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F408F-A0FD-4E90-9059-09F2FBAC3855}" type="datetimeFigureOut">
              <a:rPr lang="en-US" smtClean="0"/>
              <a:t>3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55148-D7E4-4E07-AC51-DA9CFB352B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28178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F408F-A0FD-4E90-9059-09F2FBAC3855}" type="datetimeFigureOut">
              <a:rPr lang="en-US" smtClean="0"/>
              <a:t>3/2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55148-D7E4-4E07-AC51-DA9CFB352B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86614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F408F-A0FD-4E90-9059-09F2FBAC3855}" type="datetimeFigureOut">
              <a:rPr lang="en-US" smtClean="0"/>
              <a:t>3/20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55148-D7E4-4E07-AC51-DA9CFB352B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86645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F408F-A0FD-4E90-9059-09F2FBAC3855}" type="datetimeFigureOut">
              <a:rPr lang="en-US" smtClean="0"/>
              <a:t>3/20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55148-D7E4-4E07-AC51-DA9CFB352B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69540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F408F-A0FD-4E90-9059-09F2FBAC3855}" type="datetimeFigureOut">
              <a:rPr lang="en-US" smtClean="0"/>
              <a:t>3/20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55148-D7E4-4E07-AC51-DA9CFB352B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48395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F408F-A0FD-4E90-9059-09F2FBAC3855}" type="datetimeFigureOut">
              <a:rPr lang="en-US" smtClean="0"/>
              <a:t>3/2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55148-D7E4-4E07-AC51-DA9CFB352B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82365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9F408F-A0FD-4E90-9059-09F2FBAC3855}" type="datetimeFigureOut">
              <a:rPr lang="en-US" smtClean="0"/>
              <a:t>3/2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A55148-D7E4-4E07-AC51-DA9CFB352B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91590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9F408F-A0FD-4E90-9059-09F2FBAC3855}" type="datetimeFigureOut">
              <a:rPr lang="en-US" smtClean="0"/>
              <a:t>3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A55148-D7E4-4E07-AC51-DA9CFB352B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66934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1193" r="89138"/>
          <a:stretch/>
        </p:blipFill>
        <p:spPr>
          <a:xfrm>
            <a:off x="3420578" y="678582"/>
            <a:ext cx="2452461" cy="5935578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049" t="51193" r="56917"/>
          <a:stretch/>
        </p:blipFill>
        <p:spPr>
          <a:xfrm>
            <a:off x="6043462" y="678582"/>
            <a:ext cx="1588168" cy="5935578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793" t="51061" r="49173" b="132"/>
          <a:stretch/>
        </p:blipFill>
        <p:spPr>
          <a:xfrm>
            <a:off x="8596137" y="678582"/>
            <a:ext cx="1588168" cy="5935578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490" t="51193" r="32476"/>
          <a:stretch/>
        </p:blipFill>
        <p:spPr>
          <a:xfrm>
            <a:off x="10354728" y="678581"/>
            <a:ext cx="1588168" cy="5935578"/>
          </a:xfrm>
          <a:prstGeom prst="rect">
            <a:avLst/>
          </a:prstGeom>
        </p:spPr>
      </p:pic>
      <p:cxnSp>
        <p:nvCxnSpPr>
          <p:cNvPr id="11" name="Straight Arrow Connector 10"/>
          <p:cNvCxnSpPr/>
          <p:nvPr/>
        </p:nvCxnSpPr>
        <p:spPr>
          <a:xfrm>
            <a:off x="6995795" y="534035"/>
            <a:ext cx="3176" cy="144546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14" name="Right Brace 13"/>
          <p:cNvSpPr/>
          <p:nvPr/>
        </p:nvSpPr>
        <p:spPr>
          <a:xfrm>
            <a:off x="7687027" y="3328035"/>
            <a:ext cx="137110" cy="2324100"/>
          </a:xfrm>
          <a:prstGeom prst="rightBrace">
            <a:avLst>
              <a:gd name="adj1" fmla="val 40891"/>
              <a:gd name="adj2" fmla="val 51435"/>
            </a:avLst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5" name="Right Brace 14"/>
          <p:cNvSpPr/>
          <p:nvPr/>
        </p:nvSpPr>
        <p:spPr>
          <a:xfrm>
            <a:off x="7701013" y="678581"/>
            <a:ext cx="123123" cy="2649453"/>
          </a:xfrm>
          <a:prstGeom prst="rightBrace">
            <a:avLst>
              <a:gd name="adj1" fmla="val 40891"/>
              <a:gd name="adj2" fmla="val 51435"/>
            </a:avLst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6" name="TextBox 15"/>
          <p:cNvSpPr txBox="1"/>
          <p:nvPr/>
        </p:nvSpPr>
        <p:spPr>
          <a:xfrm>
            <a:off x="7928008" y="1897380"/>
            <a:ext cx="533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 smtClean="0"/>
              <a:t>CNL</a:t>
            </a:r>
            <a:endParaRPr lang="es-ES" sz="1400" dirty="0"/>
          </a:p>
        </p:txBody>
      </p:sp>
      <p:sp>
        <p:nvSpPr>
          <p:cNvPr id="17" name="TextBox 16"/>
          <p:cNvSpPr txBox="1"/>
          <p:nvPr/>
        </p:nvSpPr>
        <p:spPr>
          <a:xfrm>
            <a:off x="7928008" y="4336196"/>
            <a:ext cx="533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/>
              <a:t>T</a:t>
            </a:r>
            <a:r>
              <a:rPr lang="es-ES" sz="1400" dirty="0" smtClean="0"/>
              <a:t>NL</a:t>
            </a:r>
            <a:endParaRPr lang="es-ES" sz="1400" dirty="0"/>
          </a:p>
        </p:txBody>
      </p:sp>
      <p:cxnSp>
        <p:nvCxnSpPr>
          <p:cNvPr id="20" name="Straight Connector 19"/>
          <p:cNvCxnSpPr/>
          <p:nvPr/>
        </p:nvCxnSpPr>
        <p:spPr>
          <a:xfrm>
            <a:off x="4812682" y="480695"/>
            <a:ext cx="537411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6458384" y="480695"/>
            <a:ext cx="537411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9121515" y="480695"/>
            <a:ext cx="537411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10767410" y="480694"/>
            <a:ext cx="537411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4729744" y="172918"/>
            <a:ext cx="7032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 smtClean="0"/>
              <a:t>P-</a:t>
            </a:r>
            <a:r>
              <a:rPr lang="es-ES" sz="1400" dirty="0" err="1" smtClean="0"/>
              <a:t>loop</a:t>
            </a:r>
            <a:endParaRPr lang="es-ES" sz="1400" dirty="0"/>
          </a:p>
        </p:txBody>
      </p:sp>
      <p:sp>
        <p:nvSpPr>
          <p:cNvPr id="25" name="TextBox 24"/>
          <p:cNvSpPr txBox="1"/>
          <p:nvPr/>
        </p:nvSpPr>
        <p:spPr>
          <a:xfrm>
            <a:off x="6314600" y="172917"/>
            <a:ext cx="810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 smtClean="0"/>
              <a:t>Kinase-2</a:t>
            </a:r>
            <a:endParaRPr lang="es-ES" sz="1400" dirty="0"/>
          </a:p>
        </p:txBody>
      </p:sp>
      <p:sp>
        <p:nvSpPr>
          <p:cNvPr id="26" name="TextBox 25"/>
          <p:cNvSpPr txBox="1"/>
          <p:nvPr/>
        </p:nvSpPr>
        <p:spPr>
          <a:xfrm>
            <a:off x="8708343" y="172916"/>
            <a:ext cx="14563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 smtClean="0"/>
              <a:t>       kinase-3</a:t>
            </a:r>
            <a:endParaRPr lang="es-ES" sz="1400" dirty="0"/>
          </a:p>
        </p:txBody>
      </p:sp>
      <p:sp>
        <p:nvSpPr>
          <p:cNvPr id="27" name="TextBox 26"/>
          <p:cNvSpPr txBox="1"/>
          <p:nvPr/>
        </p:nvSpPr>
        <p:spPr>
          <a:xfrm>
            <a:off x="10670387" y="172916"/>
            <a:ext cx="810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 smtClean="0"/>
              <a:t>GLPLA</a:t>
            </a:r>
            <a:endParaRPr lang="es-ES" sz="1400" dirty="0"/>
          </a:p>
        </p:txBody>
      </p:sp>
      <p:sp>
        <p:nvSpPr>
          <p:cNvPr id="2" name="TextBox 1"/>
          <p:cNvSpPr txBox="1"/>
          <p:nvPr/>
        </p:nvSpPr>
        <p:spPr>
          <a:xfrm>
            <a:off x="36316" y="1702348"/>
            <a:ext cx="3328865" cy="28931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 smtClean="0"/>
              <a:t>Additional file 5.- </a:t>
            </a:r>
            <a:r>
              <a:rPr lang="en-GB" sz="1400" b="1" dirty="0"/>
              <a:t>NBS multiple alignment and subdomain conservation </a:t>
            </a:r>
            <a:endParaRPr lang="en-GB" sz="1400" b="1" dirty="0" smtClean="0"/>
          </a:p>
          <a:p>
            <a:pPr algn="just"/>
            <a:r>
              <a:rPr lang="en-US" sz="1400" dirty="0" smtClean="0"/>
              <a:t>A </a:t>
            </a:r>
            <a:r>
              <a:rPr lang="en-US" sz="1400" dirty="0" smtClean="0"/>
              <a:t>subset </a:t>
            </a:r>
            <a:r>
              <a:rPr lang="en-US" sz="1400" dirty="0" smtClean="0"/>
              <a:t>of CNL and TNL NBS domains were aligned to show the conserved subdomains; p-loop, kinase-2, kinase-3 and GLPLA. A diagnostic site (red arrow) previously reported (Lopez et. al 2003) presents a W (Tryptophan) for most CNL genes and a D (Aspartic acid) for most TNL. More evident variations like the region before the kinase-2 region were captured by the phylogenetic trees to separate the two groups.  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9381090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0</Words>
  <Application>Microsoft Office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berto Jesus Lozano Gonzalez del Valle</dc:creator>
  <cp:lastModifiedBy>Usuario de Windows</cp:lastModifiedBy>
  <cp:revision>2</cp:revision>
  <dcterms:created xsi:type="dcterms:W3CDTF">2015-02-02T00:46:14Z</dcterms:created>
  <dcterms:modified xsi:type="dcterms:W3CDTF">2015-03-20T20:08:24Z</dcterms:modified>
</cp:coreProperties>
</file>